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4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293"/>
    <p:restoredTop sz="79328" autoAdjust="0"/>
  </p:normalViewPr>
  <p:slideViewPr>
    <p:cSldViewPr snapToGrid="0">
      <p:cViewPr>
        <p:scale>
          <a:sx n="70" d="100"/>
          <a:sy n="70" d="100"/>
        </p:scale>
        <p:origin x="-2424" y="-7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1C52CBF-1EAC-954E-9294-16DA8F2DF208}" type="datetimeFigureOut">
              <a:rPr lang="en-US" smtClean="0"/>
              <a:t>6/30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955B2C-DC72-4F49-B133-4E24D1E241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65166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400" b="1" kern="120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S1 Fig. </a:t>
            </a:r>
            <a:r>
              <a:rPr lang="en-US" sz="1400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Identification of a germinal </a:t>
            </a:r>
            <a:r>
              <a:rPr lang="en-US" sz="1400" kern="1200" dirty="0" err="1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revertant</a:t>
            </a:r>
            <a:r>
              <a:rPr lang="en-US" sz="1400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 from a progeny row of a single mutable T322 (</a:t>
            </a:r>
            <a:r>
              <a:rPr lang="en-US" sz="1400" i="1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w4-m</a:t>
            </a:r>
            <a:r>
              <a:rPr lang="en-US" sz="1400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) plant. Approximately 150 progeny of a mutable plant identified in an earlier experiment were grown in a 15-foot long plot to locate a germinal </a:t>
            </a:r>
            <a:r>
              <a:rPr lang="en-US" sz="1400" kern="1200" dirty="0" err="1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revertant</a:t>
            </a:r>
            <a:r>
              <a:rPr lang="en-US" sz="1400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 with only purple flowers. </a:t>
            </a:r>
          </a:p>
          <a:p>
            <a:endParaRPr 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7955B2C-DC72-4F49-B133-4E24D1E2414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96414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7EB33-1054-43FD-98F4-02213E0186DB}" type="datetimeFigureOut">
              <a:rPr lang="en-US" smtClean="0"/>
              <a:t>6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A59E2-7D88-4E50-90E2-76B2A8F58A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07135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7EB33-1054-43FD-98F4-02213E0186DB}" type="datetimeFigureOut">
              <a:rPr lang="en-US" smtClean="0"/>
              <a:t>6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A59E2-7D88-4E50-90E2-76B2A8F58A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19497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7EB33-1054-43FD-98F4-02213E0186DB}" type="datetimeFigureOut">
              <a:rPr lang="en-US" smtClean="0"/>
              <a:t>6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A59E2-7D88-4E50-90E2-76B2A8F58A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04854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7EB33-1054-43FD-98F4-02213E0186DB}" type="datetimeFigureOut">
              <a:rPr lang="en-US" smtClean="0"/>
              <a:t>6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A59E2-7D88-4E50-90E2-76B2A8F58A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57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7EB33-1054-43FD-98F4-02213E0186DB}" type="datetimeFigureOut">
              <a:rPr lang="en-US" smtClean="0"/>
              <a:t>6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A59E2-7D88-4E50-90E2-76B2A8F58A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029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7EB33-1054-43FD-98F4-02213E0186DB}" type="datetimeFigureOut">
              <a:rPr lang="en-US" smtClean="0"/>
              <a:t>6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A59E2-7D88-4E50-90E2-76B2A8F58A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37456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7EB33-1054-43FD-98F4-02213E0186DB}" type="datetimeFigureOut">
              <a:rPr lang="en-US" smtClean="0"/>
              <a:t>6/3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A59E2-7D88-4E50-90E2-76B2A8F58A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67917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7EB33-1054-43FD-98F4-02213E0186DB}" type="datetimeFigureOut">
              <a:rPr lang="en-US" smtClean="0"/>
              <a:t>6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A59E2-7D88-4E50-90E2-76B2A8F58A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07157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7EB33-1054-43FD-98F4-02213E0186DB}" type="datetimeFigureOut">
              <a:rPr lang="en-US" smtClean="0"/>
              <a:t>6/3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A59E2-7D88-4E50-90E2-76B2A8F58A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6296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7EB33-1054-43FD-98F4-02213E0186DB}" type="datetimeFigureOut">
              <a:rPr lang="en-US" smtClean="0"/>
              <a:t>6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A59E2-7D88-4E50-90E2-76B2A8F58A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88102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7EB33-1054-43FD-98F4-02213E0186DB}" type="datetimeFigureOut">
              <a:rPr lang="en-US" smtClean="0"/>
              <a:t>6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A59E2-7D88-4E50-90E2-76B2A8F58A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2662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07EB33-1054-43FD-98F4-02213E0186DB}" type="datetimeFigureOut">
              <a:rPr lang="en-US" smtClean="0"/>
              <a:t>6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0A59E2-7D88-4E50-90E2-76B2A8F58A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9155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Picture 29" descr="Front Cover 2.jpg"/>
          <p:cNvPicPr>
            <a:picLocks noChangeAspect="1"/>
          </p:cNvPicPr>
          <p:nvPr/>
        </p:nvPicPr>
        <p:blipFill rotWithShape="1">
          <a:blip r:embed="rId3" cstate="print"/>
          <a:srcRect l="18235" t="24965" r="19117" b="20246"/>
          <a:stretch/>
        </p:blipFill>
        <p:spPr>
          <a:xfrm>
            <a:off x="2839973" y="1165393"/>
            <a:ext cx="1243251" cy="1340567"/>
          </a:xfrm>
          <a:prstGeom prst="rect">
            <a:avLst/>
          </a:prstGeom>
        </p:spPr>
      </p:pic>
      <p:grpSp>
        <p:nvGrpSpPr>
          <p:cNvPr id="25" name="Group 24"/>
          <p:cNvGrpSpPr/>
          <p:nvPr/>
        </p:nvGrpSpPr>
        <p:grpSpPr>
          <a:xfrm>
            <a:off x="847161" y="3600474"/>
            <a:ext cx="5228875" cy="797657"/>
            <a:chOff x="847161" y="3681156"/>
            <a:chExt cx="5228875" cy="797657"/>
          </a:xfrm>
        </p:grpSpPr>
        <p:pic>
          <p:nvPicPr>
            <p:cNvPr id="5" name="Content Placeholder 3" descr="dark soybean flower2.tif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119" t="7896" r="17303" b="11293"/>
            <a:stretch>
              <a:fillRect/>
            </a:stretch>
          </p:blipFill>
          <p:spPr bwMode="auto">
            <a:xfrm rot="16200000">
              <a:off x="798077" y="3733595"/>
              <a:ext cx="790947" cy="6927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Content Placeholder 3" descr="dark soybean flower2.tif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119" t="7896" r="17303" b="11293"/>
            <a:stretch>
              <a:fillRect/>
            </a:stretch>
          </p:blipFill>
          <p:spPr bwMode="auto">
            <a:xfrm rot="16200000">
              <a:off x="3833033" y="3733595"/>
              <a:ext cx="790947" cy="6927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" name="Content Placeholder 3" descr="dark soybean flower2.tif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119" t="7896" r="17303" b="11293"/>
            <a:stretch>
              <a:fillRect/>
            </a:stretch>
          </p:blipFill>
          <p:spPr bwMode="auto">
            <a:xfrm rot="16200000">
              <a:off x="1558773" y="3733594"/>
              <a:ext cx="790947" cy="6927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" name="Content Placeholder 3" descr="dark soybean flower2.tif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119" t="7896" r="17303" b="11293"/>
            <a:stretch>
              <a:fillRect/>
            </a:stretch>
          </p:blipFill>
          <p:spPr bwMode="auto">
            <a:xfrm rot="16200000">
              <a:off x="2312664" y="3733595"/>
              <a:ext cx="790947" cy="6927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9" name="Content Placeholder 3" descr="dark soybean flower2.tif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119" t="7896" r="17303" b="11293"/>
            <a:stretch>
              <a:fillRect/>
            </a:stretch>
          </p:blipFill>
          <p:spPr bwMode="auto">
            <a:xfrm rot="16200000">
              <a:off x="4586925" y="3733595"/>
              <a:ext cx="790947" cy="6927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" name="Content Placeholder 3" descr="dark soybean flower2.tif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119" t="7896" r="17303" b="11293"/>
            <a:stretch>
              <a:fillRect/>
            </a:stretch>
          </p:blipFill>
          <p:spPr bwMode="auto">
            <a:xfrm rot="16200000">
              <a:off x="5334173" y="3733595"/>
              <a:ext cx="790947" cy="6927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" name="Content Placeholder 3" descr="close up soyflower.tif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225" t="1331" r="16878" b="4214"/>
            <a:stretch>
              <a:fillRect/>
            </a:stretch>
          </p:blipFill>
          <p:spPr bwMode="auto">
            <a:xfrm>
              <a:off x="3117356" y="3681156"/>
              <a:ext cx="698724" cy="7976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16" name="TextBox 15"/>
          <p:cNvSpPr txBox="1"/>
          <p:nvPr/>
        </p:nvSpPr>
        <p:spPr>
          <a:xfrm>
            <a:off x="2076023" y="4886022"/>
            <a:ext cx="277115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/>
                <a:cs typeface="Arial"/>
              </a:rPr>
              <a:t>Select a progeny with only purple flowers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865909" y="3139380"/>
            <a:ext cx="51723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/>
                <a:cs typeface="Arial"/>
              </a:rPr>
              <a:t>Progenies of a mutable plant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20" name="TextBox 5"/>
          <p:cNvSpPr txBox="1">
            <a:spLocks noChangeArrowheads="1"/>
          </p:cNvSpPr>
          <p:nvPr/>
        </p:nvSpPr>
        <p:spPr bwMode="auto">
          <a:xfrm>
            <a:off x="4068401" y="1521676"/>
            <a:ext cx="2084835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800" dirty="0" smtClean="0">
                <a:latin typeface="Arial"/>
                <a:cs typeface="Arial"/>
              </a:rPr>
              <a:t>A mutable plant </a:t>
            </a:r>
            <a:r>
              <a:rPr lang="en-US" sz="1800" i="1" dirty="0" smtClean="0">
                <a:latin typeface="Arial"/>
                <a:cs typeface="Arial"/>
              </a:rPr>
              <a:t>(w4-</a:t>
            </a:r>
            <a:r>
              <a:rPr lang="en-US" sz="1800" dirty="0" smtClean="0">
                <a:latin typeface="Arial"/>
                <a:cs typeface="Arial"/>
              </a:rPr>
              <a:t>m)</a:t>
            </a:r>
            <a:endParaRPr lang="en-US" sz="1800" dirty="0">
              <a:latin typeface="Arial"/>
              <a:cs typeface="Arial"/>
            </a:endParaRPr>
          </a:p>
        </p:txBody>
      </p:sp>
      <p:cxnSp>
        <p:nvCxnSpPr>
          <p:cNvPr id="27" name="Straight Arrow Connector 26"/>
          <p:cNvCxnSpPr/>
          <p:nvPr/>
        </p:nvCxnSpPr>
        <p:spPr>
          <a:xfrm>
            <a:off x="3461598" y="2632591"/>
            <a:ext cx="0" cy="552531"/>
          </a:xfrm>
          <a:prstGeom prst="straightConnector1">
            <a:avLst/>
          </a:prstGeom>
          <a:ln w="571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/>
          <p:nvPr/>
        </p:nvCxnSpPr>
        <p:spPr>
          <a:xfrm>
            <a:off x="3461598" y="4441067"/>
            <a:ext cx="0" cy="552531"/>
          </a:xfrm>
          <a:prstGeom prst="straightConnector1">
            <a:avLst/>
          </a:prstGeom>
          <a:ln w="571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2339667" y="6167978"/>
            <a:ext cx="224386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/>
                <a:cs typeface="Arial"/>
              </a:rPr>
              <a:t>Harvest leaf tissues and seeds</a:t>
            </a:r>
            <a:endParaRPr lang="en-US" dirty="0">
              <a:latin typeface="Arial"/>
              <a:cs typeface="Arial"/>
            </a:endParaRPr>
          </a:p>
        </p:txBody>
      </p:sp>
      <p:cxnSp>
        <p:nvCxnSpPr>
          <p:cNvPr id="32" name="Straight Arrow Connector 31"/>
          <p:cNvCxnSpPr/>
          <p:nvPr/>
        </p:nvCxnSpPr>
        <p:spPr>
          <a:xfrm>
            <a:off x="3461598" y="5592404"/>
            <a:ext cx="0" cy="552531"/>
          </a:xfrm>
          <a:prstGeom prst="straightConnector1">
            <a:avLst/>
          </a:prstGeom>
          <a:ln w="571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Rectangle 20"/>
          <p:cNvSpPr/>
          <p:nvPr/>
        </p:nvSpPr>
        <p:spPr>
          <a:xfrm>
            <a:off x="4982398" y="-12239"/>
            <a:ext cx="187580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 Fig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220009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214</TotalTime>
  <Words>77</Words>
  <Application>Microsoft Office PowerPoint</Application>
  <PresentationFormat>On-screen Show (4:3)</PresentationFormat>
  <Paragraphs>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vinder Sandhu</dc:creator>
  <cp:lastModifiedBy>Devinder Sandhu</cp:lastModifiedBy>
  <cp:revision>99</cp:revision>
  <cp:lastPrinted>2015-11-16T15:29:33Z</cp:lastPrinted>
  <dcterms:created xsi:type="dcterms:W3CDTF">2015-11-09T22:12:57Z</dcterms:created>
  <dcterms:modified xsi:type="dcterms:W3CDTF">2017-06-30T16:18:35Z</dcterms:modified>
</cp:coreProperties>
</file>